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6858000" cy="9906000" type="A4"/>
  <p:notesSz cx="10691813" cy="7559675"/>
  <p:embeddedFontLst>
    <p:embeddedFont>
      <p:font typeface="Calibri" panose="020F0502020204030204" pitchFamily="34" charset="0"/>
      <p:regular r:id="rId6"/>
      <p:bold r:id="rId7"/>
      <p:italic r:id="rId8"/>
      <p:boldItalic r:id="rId9"/>
    </p:embeddedFont>
  </p:embeddedFontLst>
  <p:defaultTextStyle/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0" d="100"/>
          <a:sy n="120" d="100"/>
        </p:scale>
        <p:origin x="1500" y="-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3.fntdata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font" Target="fonts/font2.fntdata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1.fntdata"/><Relationship Id="rId11" Type="http://schemas.openxmlformats.org/officeDocument/2006/relationships/viewProps" Target="viewProps.xml"/><Relationship Id="rId5" Type="http://schemas.openxmlformats.org/officeDocument/2006/relationships/notesMaster" Target="notesMasters/notesMaster1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font" Target="fonts/font4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633913" cy="3794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6056313" y="0"/>
            <a:ext cx="4632325" cy="3794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07C184-9882-4FC0-8606-CB0FB07BAE76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464050" y="944563"/>
            <a:ext cx="1765300" cy="25511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i-FI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1069975" y="3638550"/>
            <a:ext cx="8553450" cy="29765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7180263"/>
            <a:ext cx="4633913" cy="379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6056313" y="7180263"/>
            <a:ext cx="4632325" cy="379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E26AFD-C021-4C3C-8BF0-0358D7AB98D4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09479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i-FI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E26AFD-C021-4C3C-8BF0-0358D7AB98D4}" type="slidenum">
              <a:rPr lang="fi-FI" smtClean="0"/>
              <a:t>1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297097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i-FI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E26AFD-C021-4C3C-8BF0-0358D7AB98D4}" type="slidenum">
              <a:rPr lang="fi-FI" smtClean="0"/>
              <a:t>3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8064202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44239"/>
            <a:ext cx="6805684" cy="44863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333767" y="29115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i-FI" dirty="0"/>
          </a:p>
        </p:txBody>
      </p:sp>
      <p:sp>
        <p:nvSpPr>
          <p:cNvPr id="11" name="TextBox 10"/>
          <p:cNvSpPr txBox="1"/>
          <p:nvPr/>
        </p:nvSpPr>
        <p:spPr>
          <a:xfrm>
            <a:off x="546359" y="85762"/>
            <a:ext cx="6079294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Supplemental Figure 2. Panel A. Loadings of 95 metabolic measures measured at 12.6-13.4 gestational weeks </a:t>
            </a:r>
          </a:p>
          <a:p>
            <a:r>
              <a:rPr lang="en-US" sz="800" b="1" dirty="0" smtClean="0"/>
              <a:t>on the maternal pre-pregnancy BMI-defined metabolome</a:t>
            </a:r>
            <a:endParaRPr lang="fi-FI" sz="800" b="1" dirty="0" smtClean="0"/>
          </a:p>
          <a:p>
            <a:endParaRPr lang="fi-FI" dirty="0"/>
          </a:p>
        </p:txBody>
      </p:sp>
      <p:sp>
        <p:nvSpPr>
          <p:cNvPr id="16" name="TextBox 15"/>
          <p:cNvSpPr txBox="1"/>
          <p:nvPr/>
        </p:nvSpPr>
        <p:spPr>
          <a:xfrm>
            <a:off x="1264926" y="9507716"/>
            <a:ext cx="60959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700" dirty="0"/>
              <a:t>-0.20  </a:t>
            </a:r>
            <a:r>
              <a:rPr lang="fi-FI" sz="700" dirty="0" smtClean="0"/>
              <a:t>            </a:t>
            </a:r>
            <a:r>
              <a:rPr lang="fi-FI" sz="700" dirty="0"/>
              <a:t>-0.15       </a:t>
            </a:r>
            <a:r>
              <a:rPr lang="fi-FI" sz="700" dirty="0" smtClean="0"/>
              <a:t>   </a:t>
            </a:r>
            <a:r>
              <a:rPr lang="fi-FI" sz="700" dirty="0" smtClean="0"/>
              <a:t>    </a:t>
            </a:r>
            <a:r>
              <a:rPr lang="fi-FI" sz="700" dirty="0"/>
              <a:t>-0.10       </a:t>
            </a:r>
            <a:r>
              <a:rPr lang="fi-FI" sz="700" dirty="0" smtClean="0"/>
              <a:t>       </a:t>
            </a:r>
            <a:r>
              <a:rPr lang="fi-FI" sz="700" dirty="0"/>
              <a:t>-0.05     </a:t>
            </a:r>
            <a:r>
              <a:rPr lang="fi-FI" sz="700" dirty="0" smtClean="0"/>
              <a:t>   </a:t>
            </a:r>
            <a:r>
              <a:rPr lang="fi-FI" sz="700" dirty="0" smtClean="0"/>
              <a:t>        </a:t>
            </a:r>
            <a:r>
              <a:rPr lang="fi-FI" sz="700" dirty="0"/>
              <a:t>0.00       </a:t>
            </a:r>
            <a:r>
              <a:rPr lang="fi-FI" sz="700" dirty="0" smtClean="0"/>
              <a:t>        </a:t>
            </a:r>
            <a:r>
              <a:rPr lang="fi-FI" sz="700" dirty="0"/>
              <a:t>0.05      </a:t>
            </a:r>
            <a:r>
              <a:rPr lang="fi-FI" sz="700" dirty="0" smtClean="0"/>
              <a:t>         </a:t>
            </a:r>
            <a:r>
              <a:rPr lang="fi-FI" sz="700" dirty="0" smtClean="0"/>
              <a:t>0.10       </a:t>
            </a:r>
            <a:r>
              <a:rPr lang="fi-FI" sz="700" dirty="0" smtClean="0"/>
              <a:t>         0.15               </a:t>
            </a:r>
            <a:r>
              <a:rPr lang="fi-FI" sz="700" dirty="0"/>
              <a:t>0.20        </a:t>
            </a:r>
            <a:r>
              <a:rPr lang="fi-FI" sz="700" dirty="0" smtClean="0"/>
              <a:t>        </a:t>
            </a:r>
            <a:r>
              <a:rPr lang="fi-FI" sz="700" dirty="0" smtClean="0"/>
              <a:t>0.25</a:t>
            </a:r>
            <a:endParaRPr lang="fi-FI" sz="700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415458" y="9546231"/>
            <a:ext cx="4770619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Picture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6359" y="458659"/>
            <a:ext cx="5591919" cy="263072"/>
          </a:xfrm>
          <a:prstGeom prst="rect">
            <a:avLst/>
          </a:prstGeom>
        </p:spPr>
      </p:pic>
      <p:pic>
        <p:nvPicPr>
          <p:cNvPr id="24" name="Picture 100"/>
          <p:cNvPicPr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 rot="5400000">
            <a:off x="-1194055" y="1672519"/>
            <a:ext cx="9189402" cy="6609907"/>
          </a:xfrm>
          <a:prstGeom prst="rect">
            <a:avLst/>
          </a:prstGeom>
          <a:noFill/>
          <a:extLst/>
        </p:spPr>
      </p:pic>
      <p:cxnSp>
        <p:nvCxnSpPr>
          <p:cNvPr id="25" name="Straight Connector 24"/>
          <p:cNvCxnSpPr/>
          <p:nvPr/>
        </p:nvCxnSpPr>
        <p:spPr>
          <a:xfrm>
            <a:off x="1415458" y="9425763"/>
            <a:ext cx="5210195" cy="1594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Picture 2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5681" y="458658"/>
            <a:ext cx="6529961" cy="310455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Picture 101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 rot="5400000">
            <a:off x="-1234967" y="1686808"/>
            <a:ext cx="9398444" cy="6265191"/>
          </a:xfrm>
          <a:prstGeom prst="rect">
            <a:avLst/>
          </a:prstGeom>
          <a:noFill/>
          <a:extLst/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274" y="168323"/>
            <a:ext cx="6803726" cy="35594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71888" y="9385110"/>
            <a:ext cx="60959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700" dirty="0"/>
              <a:t>-0.20              -0.15             -0.10              -0.05            0.00              0.05             </a:t>
            </a:r>
            <a:r>
              <a:rPr lang="fi-FI" sz="700" dirty="0" smtClean="0"/>
              <a:t>  </a:t>
            </a:r>
            <a:r>
              <a:rPr lang="fi-FI" sz="700" dirty="0"/>
              <a:t>0.10              0.15             0.20               0.25</a:t>
            </a:r>
          </a:p>
        </p:txBody>
      </p:sp>
      <p:cxnSp>
        <p:nvCxnSpPr>
          <p:cNvPr id="7" name="Straight Connector 6"/>
          <p:cNvCxnSpPr/>
          <p:nvPr/>
        </p:nvCxnSpPr>
        <p:spPr>
          <a:xfrm>
            <a:off x="1651379" y="9376012"/>
            <a:ext cx="4885899" cy="90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673289" y="162965"/>
            <a:ext cx="55819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anel </a:t>
            </a:r>
            <a:r>
              <a:rPr lang="en-US" sz="800" b="1" dirty="0"/>
              <a:t>B</a:t>
            </a:r>
            <a:r>
              <a:rPr lang="en-US" sz="800" b="1" dirty="0" smtClean="0"/>
              <a:t>. Loadings of 95 metabolic measures measured at 19-19.7 gestational weeks on the maternal pre-pregnancy BMI-defined metabolome</a:t>
            </a:r>
            <a:endParaRPr lang="fi-FI" sz="8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Picture 102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 rot="5400000">
            <a:off x="-1382657" y="1765607"/>
            <a:ext cx="9572513" cy="6270172"/>
          </a:xfrm>
          <a:prstGeom prst="rect">
            <a:avLst/>
          </a:prstGeom>
          <a:noFill/>
          <a:extLst/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4985" y="114437"/>
            <a:ext cx="5777869" cy="4178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807216" y="9572642"/>
            <a:ext cx="63085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700" dirty="0"/>
              <a:t>-0.20    </a:t>
            </a:r>
            <a:r>
              <a:rPr lang="fi-FI" sz="700" dirty="0" smtClean="0"/>
              <a:t>      </a:t>
            </a:r>
            <a:r>
              <a:rPr lang="fi-FI" sz="700" dirty="0"/>
              <a:t>-0.15       </a:t>
            </a:r>
            <a:r>
              <a:rPr lang="fi-FI" sz="700" dirty="0" smtClean="0"/>
              <a:t>    </a:t>
            </a:r>
            <a:r>
              <a:rPr lang="fi-FI" sz="700" dirty="0"/>
              <a:t>-0.10        </a:t>
            </a:r>
            <a:r>
              <a:rPr lang="fi-FI" sz="700" dirty="0" smtClean="0"/>
              <a:t>   </a:t>
            </a:r>
            <a:r>
              <a:rPr lang="fi-FI" sz="700" dirty="0"/>
              <a:t>-0.05    </a:t>
            </a:r>
            <a:r>
              <a:rPr lang="fi-FI" sz="700" dirty="0" smtClean="0"/>
              <a:t>   </a:t>
            </a:r>
            <a:r>
              <a:rPr lang="fi-FI" sz="700" dirty="0"/>
              <a:t>0.00     </a:t>
            </a:r>
            <a:r>
              <a:rPr lang="fi-FI" sz="700" dirty="0" smtClean="0"/>
              <a:t>     </a:t>
            </a:r>
            <a:r>
              <a:rPr lang="fi-FI" sz="700" dirty="0"/>
              <a:t>0.05        </a:t>
            </a:r>
            <a:r>
              <a:rPr lang="fi-FI" sz="700" dirty="0" smtClean="0"/>
              <a:t>   </a:t>
            </a:r>
            <a:r>
              <a:rPr lang="fi-FI" sz="700" dirty="0" smtClean="0"/>
              <a:t>0.10          </a:t>
            </a:r>
            <a:r>
              <a:rPr lang="fi-FI" sz="700" dirty="0"/>
              <a:t>0.15        </a:t>
            </a:r>
            <a:r>
              <a:rPr lang="fi-FI" sz="700" dirty="0" smtClean="0"/>
              <a:t>   </a:t>
            </a:r>
            <a:r>
              <a:rPr lang="fi-FI" sz="700" dirty="0"/>
              <a:t>0.20           </a:t>
            </a:r>
            <a:r>
              <a:rPr lang="fi-FI" sz="700" dirty="0" smtClean="0"/>
              <a:t>0.25</a:t>
            </a:r>
            <a:endParaRPr lang="fi-FI" sz="700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1646830" y="9586921"/>
            <a:ext cx="509061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471714" y="49313"/>
            <a:ext cx="626573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anel C. Loadings of 95 metabolic measures measured at 26.6-27.6 gestational weeks on the maternal pre-pregnancy BMI-defined metabolome</a:t>
            </a:r>
            <a:endParaRPr kumimoji="0" lang="fi-FI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/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105</Words>
  <Application>Microsoft Office PowerPoint</Application>
  <PresentationFormat>A4 Paper (210x297 mm)</PresentationFormat>
  <Paragraphs>9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Calibri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rchenko, Polina</dc:creator>
  <cp:lastModifiedBy>Girchenko, Polina</cp:lastModifiedBy>
  <cp:revision>13</cp:revision>
  <dcterms:modified xsi:type="dcterms:W3CDTF">2023-12-13T11:03:58Z</dcterms:modified>
</cp:coreProperties>
</file>